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78" y="16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53918B-371D-435C-B710-316FEC284A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CD6F34-5B27-4518-B6EA-40E16279E0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E6EABE-D1F6-4D76-8F22-523925414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B3670C-9CF2-4E03-9B14-B180A710C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272717-F5C4-4AE2-8B51-4D976147E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900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FECA95-5AC0-40DE-B475-69D1FAEA77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DA1480-A65F-42A3-8D27-DF558E6543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C8F9DE-84B7-4E29-A419-A7316FB69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1970E-EA0B-43B7-896B-38324422C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9A8D3B-2B9B-409C-9C56-C65A64873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170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D30880-6C67-416E-89ED-7941C5BBE2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107F0A-C1F3-4528-88D7-795A7FE28B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01102C-DBE3-480B-B8CA-C702F9A7A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46182-B299-4B13-B6F4-3F62B5EED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391724-63DA-4F05-AB1E-167EC5DEC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19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7B48B-B548-4B05-B155-5161CCAB3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4694C3-6A97-415A-A1E1-8CA9D82E59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DF0A2A-44FD-4D11-A9A8-BD4FAEAFF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4B142E-9346-4626-9DBC-C79F5193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746AB-5CB2-469A-AD01-B3B93FDC2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689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A57831-1EBC-49C8-BDA9-DA0F79B4CC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4712D5-84C6-4CA5-B617-F8DA478497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EF8C8-6ACE-4B16-8337-42DD5CAFC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33E4F5-82FB-489A-91C2-817DC8D89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1178C6-02D7-46DB-8383-46904EECB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123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7B842-666F-494C-B0A4-BFB5BE2C08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47BB83-DE38-420D-9DD9-6B4E02B07D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EE0D6D-CF7F-4EDD-A2A5-E3D32D6C9F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4577D3-1F84-4546-B37B-7C0867BA6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867069-26F8-419E-B47C-9AEE62375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62F86E-B225-48E3-AE90-4017341EC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901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EF1DD-79D5-4E9B-8ABC-0EDB72099D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96ADCE-625E-45D1-BD85-7049065E27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0FA615-2D61-43E2-B4A2-946575B489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C2B95F-716F-4CA6-ABCA-55869527BB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490F41-ED23-4B74-A118-7FFCAA5BF8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5B2541-1623-4084-AEC1-5CF53AABD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FC1C64-9133-4CE0-9637-952B30CFD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A44D35-5CDB-4229-9D98-86BE8B3F5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00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3C6CA-9B47-41ED-9D20-C84D4A4F23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5881CF-A549-4ECD-9CF7-9876311CD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BAC14F-39CA-4AD1-954F-9305C86A7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A9279A-0BFC-4CB8-B75A-900529DC4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143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E26DFB-893E-474D-93FC-56B81E6B3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57C351-6C93-4DF2-8415-8D1A91BE0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61B5FF-1157-472F-9D9F-23BE5659A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497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30CAE-9910-4046-8F7B-DA045D54CD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3D730B-B25F-4ECA-B83E-A34E36B7B8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47A115-93D3-4F63-B1E6-E5B57884AE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979E2F-AE3D-483B-9D63-B9FA28148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9EE50B-D9CE-43F2-BE71-34D0A8B58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A48AD9-6296-4C61-95B1-D984F62B3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201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34CAFE-D941-46D7-8B0B-E019D285A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563ABF1-6A98-4DC2-8F68-DDAA883793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C27B58-F584-4D4C-A548-B78297E67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343E41-9CB8-4E2E-826D-82ACE439A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18D55A-C1B3-4EA4-B288-16E94073C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F0982F-C765-410A-9803-BB1F37A66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021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C58802-CDA6-4C8D-8452-1A9675E2A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5810F8-F70B-4420-BC22-4E39AE8944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493C80-CC78-4E95-9DA8-77A46D2149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CEFCE-B613-4217-B682-BE141D39C2ED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E786C9-3FC9-4861-91C3-36F17260FA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666CD9-4478-4857-9CF0-614CCCC3FA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6189D-3278-4909-8D59-C051EE3B1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233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3010D04-CBBE-40C7-9443-B3990FF834FD}"/>
              </a:ext>
            </a:extLst>
          </p:cNvPr>
          <p:cNvSpPr txBox="1"/>
          <p:nvPr/>
        </p:nvSpPr>
        <p:spPr>
          <a:xfrm>
            <a:off x="572879" y="513302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EV5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E879DD-6385-4A06-9EA4-4E6A8A658BE9}"/>
              </a:ext>
            </a:extLst>
          </p:cNvPr>
          <p:cNvSpPr txBox="1"/>
          <p:nvPr/>
        </p:nvSpPr>
        <p:spPr>
          <a:xfrm>
            <a:off x="4463586" y="2558137"/>
            <a:ext cx="6871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m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F943FEE-289C-4D74-866F-ABA83B459548}"/>
              </a:ext>
            </a:extLst>
          </p:cNvPr>
          <p:cNvSpPr txBox="1"/>
          <p:nvPr/>
        </p:nvSpPr>
        <p:spPr>
          <a:xfrm>
            <a:off x="4386663" y="3455623"/>
            <a:ext cx="8914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0A60E35-A719-4DBB-98B1-3994616FE00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997" t="9083" r="-89" b="25024"/>
          <a:stretch/>
        </p:blipFill>
        <p:spPr>
          <a:xfrm>
            <a:off x="1182915" y="3305925"/>
            <a:ext cx="3207920" cy="7547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DF88D93-FA93-48A7-AC75-2D7196ACA53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5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5" t="7010" r="939" b="24847"/>
          <a:stretch/>
        </p:blipFill>
        <p:spPr>
          <a:xfrm>
            <a:off x="1214092" y="2321866"/>
            <a:ext cx="3207920" cy="6862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730E4EE-6005-48CB-9C55-D1B36ADAB81B}"/>
              </a:ext>
            </a:extLst>
          </p:cNvPr>
          <p:cNvSpPr txBox="1"/>
          <p:nvPr/>
        </p:nvSpPr>
        <p:spPr>
          <a:xfrm>
            <a:off x="766412" y="2723035"/>
            <a:ext cx="3684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A183B447-AAC4-4300-9977-7311C525254C}"/>
              </a:ext>
            </a:extLst>
          </p:cNvPr>
          <p:cNvCxnSpPr>
            <a:cxnSpLocks/>
          </p:cNvCxnSpPr>
          <p:nvPr/>
        </p:nvCxnSpPr>
        <p:spPr>
          <a:xfrm>
            <a:off x="1094200" y="2843673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1DD26473-C4A1-40C4-9E21-ED95AEC82C47}"/>
              </a:ext>
            </a:extLst>
          </p:cNvPr>
          <p:cNvSpPr txBox="1"/>
          <p:nvPr/>
        </p:nvSpPr>
        <p:spPr>
          <a:xfrm>
            <a:off x="806169" y="3282475"/>
            <a:ext cx="3684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E82AC35-FFF0-4AA4-86C9-EDCD481225B4}"/>
              </a:ext>
            </a:extLst>
          </p:cNvPr>
          <p:cNvCxnSpPr>
            <a:cxnSpLocks/>
          </p:cNvCxnSpPr>
          <p:nvPr/>
        </p:nvCxnSpPr>
        <p:spPr>
          <a:xfrm>
            <a:off x="1070347" y="3379261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18C513FB-5D51-41E0-861F-6E8D857F125A}"/>
              </a:ext>
            </a:extLst>
          </p:cNvPr>
          <p:cNvSpPr txBox="1"/>
          <p:nvPr/>
        </p:nvSpPr>
        <p:spPr>
          <a:xfrm>
            <a:off x="767852" y="2407141"/>
            <a:ext cx="3684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D1269F3E-D46B-41D3-A4C5-3AC9295D9509}"/>
              </a:ext>
            </a:extLst>
          </p:cNvPr>
          <p:cNvCxnSpPr>
            <a:cxnSpLocks/>
          </p:cNvCxnSpPr>
          <p:nvPr/>
        </p:nvCxnSpPr>
        <p:spPr>
          <a:xfrm>
            <a:off x="1095640" y="2527779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413CE749-2C93-41A4-9266-D3DF52C66231}"/>
              </a:ext>
            </a:extLst>
          </p:cNvPr>
          <p:cNvSpPr txBox="1"/>
          <p:nvPr/>
        </p:nvSpPr>
        <p:spPr>
          <a:xfrm>
            <a:off x="1302622" y="1874389"/>
            <a:ext cx="84501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ambled</a:t>
            </a:r>
          </a:p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N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F03A2ED-54AD-417B-AB3E-1B62116B8A3B}"/>
              </a:ext>
            </a:extLst>
          </p:cNvPr>
          <p:cNvSpPr txBox="1"/>
          <p:nvPr/>
        </p:nvSpPr>
        <p:spPr>
          <a:xfrm>
            <a:off x="1922238" y="1874389"/>
            <a:ext cx="84501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E1</a:t>
            </a:r>
            <a:r>
              <a:rPr lang="el-G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N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0AFA40-5110-44FA-9784-002151929DBB}"/>
              </a:ext>
            </a:extLst>
          </p:cNvPr>
          <p:cNvSpPr txBox="1"/>
          <p:nvPr/>
        </p:nvSpPr>
        <p:spPr>
          <a:xfrm>
            <a:off x="2585322" y="1874389"/>
            <a:ext cx="84501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ambled</a:t>
            </a:r>
          </a:p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N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AF37DC-518F-4B74-BFC5-C271388B2C5D}"/>
              </a:ext>
            </a:extLst>
          </p:cNvPr>
          <p:cNvSpPr txBox="1"/>
          <p:nvPr/>
        </p:nvSpPr>
        <p:spPr>
          <a:xfrm>
            <a:off x="3204938" y="1874389"/>
            <a:ext cx="84501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E1</a:t>
            </a:r>
            <a:r>
              <a:rPr lang="el-G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NA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E16DA655-7BD9-40F7-8369-7EE4E9FDE354}"/>
              </a:ext>
            </a:extLst>
          </p:cNvPr>
          <p:cNvCxnSpPr/>
          <p:nvPr/>
        </p:nvCxnSpPr>
        <p:spPr>
          <a:xfrm>
            <a:off x="1302622" y="1854200"/>
            <a:ext cx="127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0CB6B09-5A5C-4AB2-A018-11CB828131FE}"/>
              </a:ext>
            </a:extLst>
          </p:cNvPr>
          <p:cNvCxnSpPr/>
          <p:nvPr/>
        </p:nvCxnSpPr>
        <p:spPr>
          <a:xfrm>
            <a:off x="2661522" y="1854200"/>
            <a:ext cx="127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D8899AE-D084-4BD8-82D7-95A359AC88B7}"/>
              </a:ext>
            </a:extLst>
          </p:cNvPr>
          <p:cNvSpPr txBox="1"/>
          <p:nvPr/>
        </p:nvSpPr>
        <p:spPr>
          <a:xfrm>
            <a:off x="1523944" y="1621522"/>
            <a:ext cx="8450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BA6635D-F6DF-4EF2-8141-0C8D1E641401}"/>
              </a:ext>
            </a:extLst>
          </p:cNvPr>
          <p:cNvSpPr txBox="1"/>
          <p:nvPr/>
        </p:nvSpPr>
        <p:spPr>
          <a:xfrm>
            <a:off x="2874015" y="1621522"/>
            <a:ext cx="8450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mk O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ACEB8B-BAA4-436A-9E4A-787559885F9F}"/>
              </a:ext>
            </a:extLst>
          </p:cNvPr>
          <p:cNvSpPr txBox="1"/>
          <p:nvPr/>
        </p:nvSpPr>
        <p:spPr>
          <a:xfrm>
            <a:off x="590112" y="2063173"/>
            <a:ext cx="6871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1432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, Aniket Sunil</dc:creator>
  <cp:lastModifiedBy>Joshi, Aniket Sunil</cp:lastModifiedBy>
  <cp:revision>3</cp:revision>
  <dcterms:created xsi:type="dcterms:W3CDTF">2024-04-16T16:51:45Z</dcterms:created>
  <dcterms:modified xsi:type="dcterms:W3CDTF">2024-04-16T19:32:46Z</dcterms:modified>
</cp:coreProperties>
</file>